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2" d="100"/>
          <a:sy n="112" d="100"/>
        </p:scale>
        <p:origin x="51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2EA70-05CD-46C1-82C7-F883E0B18400}" type="datetimeFigureOut">
              <a:rPr lang="en-US" smtClean="0"/>
              <a:t>8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C5659-2CD5-4A8B-B1EF-2A85B81DDE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7784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2EA70-05CD-46C1-82C7-F883E0B18400}" type="datetimeFigureOut">
              <a:rPr lang="en-US" smtClean="0"/>
              <a:t>8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C5659-2CD5-4A8B-B1EF-2A85B81DDE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28725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2EA70-05CD-46C1-82C7-F883E0B18400}" type="datetimeFigureOut">
              <a:rPr lang="en-US" smtClean="0"/>
              <a:t>8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C5659-2CD5-4A8B-B1EF-2A85B81DDE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1883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2EA70-05CD-46C1-82C7-F883E0B18400}" type="datetimeFigureOut">
              <a:rPr lang="en-US" smtClean="0"/>
              <a:t>8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C5659-2CD5-4A8B-B1EF-2A85B81DDE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51888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2EA70-05CD-46C1-82C7-F883E0B18400}" type="datetimeFigureOut">
              <a:rPr lang="en-US" smtClean="0"/>
              <a:t>8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C5659-2CD5-4A8B-B1EF-2A85B81DDE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44054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2EA70-05CD-46C1-82C7-F883E0B18400}" type="datetimeFigureOut">
              <a:rPr lang="en-US" smtClean="0"/>
              <a:t>8/1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C5659-2CD5-4A8B-B1EF-2A85B81DDE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24036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2EA70-05CD-46C1-82C7-F883E0B18400}" type="datetimeFigureOut">
              <a:rPr lang="en-US" smtClean="0"/>
              <a:t>8/13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C5659-2CD5-4A8B-B1EF-2A85B81DDE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3505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2EA70-05CD-46C1-82C7-F883E0B18400}" type="datetimeFigureOut">
              <a:rPr lang="en-US" smtClean="0"/>
              <a:t>8/13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C5659-2CD5-4A8B-B1EF-2A85B81DDE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54111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2EA70-05CD-46C1-82C7-F883E0B18400}" type="datetimeFigureOut">
              <a:rPr lang="en-US" smtClean="0"/>
              <a:t>8/13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C5659-2CD5-4A8B-B1EF-2A85B81DDE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23309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2EA70-05CD-46C1-82C7-F883E0B18400}" type="datetimeFigureOut">
              <a:rPr lang="en-US" smtClean="0"/>
              <a:t>8/1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C5659-2CD5-4A8B-B1EF-2A85B81DDE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04945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2EA70-05CD-46C1-82C7-F883E0B18400}" type="datetimeFigureOut">
              <a:rPr lang="en-US" smtClean="0"/>
              <a:t>8/1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C5659-2CD5-4A8B-B1EF-2A85B81DDE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9809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F2EA70-05CD-46C1-82C7-F883E0B18400}" type="datetimeFigureOut">
              <a:rPr lang="en-US" smtClean="0"/>
              <a:t>8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2C5659-2CD5-4A8B-B1EF-2A85B81DDE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93694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299884" y="0"/>
            <a:ext cx="288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nitial 2-compartment </a:t>
            </a:r>
            <a:r>
              <a:rPr lang="en-US" dirty="0" smtClean="0"/>
              <a:t>model</a:t>
            </a:r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49078" y="316742"/>
            <a:ext cx="4508687" cy="2297342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45729" y="2567662"/>
            <a:ext cx="4412036" cy="225166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18846" y="4799371"/>
            <a:ext cx="4338919" cy="2052294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5849493" y="-52590"/>
            <a:ext cx="2806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nal 2-compartment </a:t>
            </a:r>
            <a:r>
              <a:rPr lang="en-US" dirty="0" smtClean="0"/>
              <a:t>model</a:t>
            </a:r>
            <a:endParaRPr lang="en-US" dirty="0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65017" y="369332"/>
            <a:ext cx="4323551" cy="2221992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43483" y="2663916"/>
            <a:ext cx="4245085" cy="2185988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15197" y="4849904"/>
            <a:ext cx="4091807" cy="19716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673090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995084" y="649002"/>
            <a:ext cx="288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nitial 2-compartment </a:t>
            </a:r>
            <a:r>
              <a:rPr lang="en-US" dirty="0" smtClean="0"/>
              <a:t>model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995084" y="2570251"/>
            <a:ext cx="2806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nal 2-compartment </a:t>
            </a:r>
            <a:r>
              <a:rPr lang="en-US" dirty="0" smtClean="0"/>
              <a:t>model</a:t>
            </a:r>
            <a:endParaRPr lang="en-US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99857" y="987167"/>
            <a:ext cx="9820275" cy="447675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99857" y="2986759"/>
            <a:ext cx="9820275" cy="4195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030297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52963" y="937374"/>
            <a:ext cx="2558863" cy="2579837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52963" y="3965727"/>
            <a:ext cx="3049086" cy="2529663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906778" y="198947"/>
            <a:ext cx="288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nitial 2-compartment </a:t>
            </a:r>
            <a:r>
              <a:rPr lang="en-US" dirty="0" smtClean="0"/>
              <a:t>model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5022798" y="198947"/>
            <a:ext cx="2806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nal 2-compartment </a:t>
            </a:r>
            <a:r>
              <a:rPr lang="en-US" dirty="0" smtClean="0"/>
              <a:t>model</a:t>
            </a:r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36130" y="904880"/>
            <a:ext cx="2734681" cy="261234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07847" y="3748576"/>
            <a:ext cx="2345707" cy="26163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31153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18</Words>
  <Application>Microsoft Office PowerPoint</Application>
  <PresentationFormat>Widescreen</PresentationFormat>
  <Paragraphs>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>KSU College Of Veterinary Medicin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oumeng Lin</dc:creator>
  <cp:lastModifiedBy>Zhoumeng Lin</cp:lastModifiedBy>
  <cp:revision>5</cp:revision>
  <dcterms:created xsi:type="dcterms:W3CDTF">2016-08-12T14:08:52Z</dcterms:created>
  <dcterms:modified xsi:type="dcterms:W3CDTF">2016-08-13T20:30:38Z</dcterms:modified>
</cp:coreProperties>
</file>